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8" r:id="rId3"/>
    <p:sldId id="259" r:id="rId4"/>
  </p:sldIdLst>
  <p:sldSz cx="9144000" cy="6858000" type="screen4x3"/>
  <p:notesSz cx="6858000" cy="9144000"/>
  <p:defaultTextStyle>
    <a:defPPr>
      <a:defRPr lang="es-MX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07" d="100"/>
          <a:sy n="107" d="100"/>
        </p:scale>
        <p:origin x="-84" y="-1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s-MX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121550-AE17-4271-84B9-65768E32F59F}" type="datetimeFigureOut">
              <a:rPr lang="es-MX" smtClean="0"/>
              <a:pPr/>
              <a:t>22/05/2013</a:t>
            </a:fld>
            <a:endParaRPr lang="es-MX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FBCA3-9EBD-452C-BDD7-BCB7C68854B2}" type="slidenum">
              <a:rPr lang="es-MX" smtClean="0"/>
              <a:pPr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xmlns="" val="29864633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121550-AE17-4271-84B9-65768E32F59F}" type="datetimeFigureOut">
              <a:rPr lang="es-MX" smtClean="0"/>
              <a:pPr/>
              <a:t>22/05/2013</a:t>
            </a:fld>
            <a:endParaRPr lang="es-MX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FBCA3-9EBD-452C-BDD7-BCB7C68854B2}" type="slidenum">
              <a:rPr lang="es-MX" smtClean="0"/>
              <a:pPr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xmlns="" val="7543691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121550-AE17-4271-84B9-65768E32F59F}" type="datetimeFigureOut">
              <a:rPr lang="es-MX" smtClean="0"/>
              <a:pPr/>
              <a:t>22/05/2013</a:t>
            </a:fld>
            <a:endParaRPr lang="es-MX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FBCA3-9EBD-452C-BDD7-BCB7C68854B2}" type="slidenum">
              <a:rPr lang="es-MX" smtClean="0"/>
              <a:pPr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xmlns="" val="15522574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121550-AE17-4271-84B9-65768E32F59F}" type="datetimeFigureOut">
              <a:rPr lang="es-MX" smtClean="0"/>
              <a:pPr/>
              <a:t>22/05/2013</a:t>
            </a:fld>
            <a:endParaRPr lang="es-MX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FBCA3-9EBD-452C-BDD7-BCB7C68854B2}" type="slidenum">
              <a:rPr lang="es-MX" smtClean="0"/>
              <a:pPr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xmlns="" val="17608860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121550-AE17-4271-84B9-65768E32F59F}" type="datetimeFigureOut">
              <a:rPr lang="es-MX" smtClean="0"/>
              <a:pPr/>
              <a:t>22/05/2013</a:t>
            </a:fld>
            <a:endParaRPr lang="es-MX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FBCA3-9EBD-452C-BDD7-BCB7C68854B2}" type="slidenum">
              <a:rPr lang="es-MX" smtClean="0"/>
              <a:pPr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xmlns="" val="6947257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121550-AE17-4271-84B9-65768E32F59F}" type="datetimeFigureOut">
              <a:rPr lang="es-MX" smtClean="0"/>
              <a:pPr/>
              <a:t>22/05/2013</a:t>
            </a:fld>
            <a:endParaRPr lang="es-MX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FBCA3-9EBD-452C-BDD7-BCB7C68854B2}" type="slidenum">
              <a:rPr lang="es-MX" smtClean="0"/>
              <a:pPr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xmlns="" val="31276832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121550-AE17-4271-84B9-65768E32F59F}" type="datetimeFigureOut">
              <a:rPr lang="es-MX" smtClean="0"/>
              <a:pPr/>
              <a:t>22/05/2013</a:t>
            </a:fld>
            <a:endParaRPr lang="es-MX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FBCA3-9EBD-452C-BDD7-BCB7C68854B2}" type="slidenum">
              <a:rPr lang="es-MX" smtClean="0"/>
              <a:pPr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xmlns="" val="14594253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121550-AE17-4271-84B9-65768E32F59F}" type="datetimeFigureOut">
              <a:rPr lang="es-MX" smtClean="0"/>
              <a:pPr/>
              <a:t>22/05/2013</a:t>
            </a:fld>
            <a:endParaRPr lang="es-MX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FBCA3-9EBD-452C-BDD7-BCB7C68854B2}" type="slidenum">
              <a:rPr lang="es-MX" smtClean="0"/>
              <a:pPr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xmlns="" val="12051583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121550-AE17-4271-84B9-65768E32F59F}" type="datetimeFigureOut">
              <a:rPr lang="es-MX" smtClean="0"/>
              <a:pPr/>
              <a:t>22/05/2013</a:t>
            </a:fld>
            <a:endParaRPr lang="es-MX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FBCA3-9EBD-452C-BDD7-BCB7C68854B2}" type="slidenum">
              <a:rPr lang="es-MX" smtClean="0"/>
              <a:pPr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xmlns="" val="8457026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121550-AE17-4271-84B9-65768E32F59F}" type="datetimeFigureOut">
              <a:rPr lang="es-MX" smtClean="0"/>
              <a:pPr/>
              <a:t>22/05/2013</a:t>
            </a:fld>
            <a:endParaRPr lang="es-MX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FBCA3-9EBD-452C-BDD7-BCB7C68854B2}" type="slidenum">
              <a:rPr lang="es-MX" smtClean="0"/>
              <a:pPr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xmlns="" val="21524694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MX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121550-AE17-4271-84B9-65768E32F59F}" type="datetimeFigureOut">
              <a:rPr lang="es-MX" smtClean="0"/>
              <a:pPr/>
              <a:t>22/05/2013</a:t>
            </a:fld>
            <a:endParaRPr lang="es-MX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FBCA3-9EBD-452C-BDD7-BCB7C68854B2}" type="slidenum">
              <a:rPr lang="es-MX" smtClean="0"/>
              <a:pPr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xmlns="" val="10876456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121550-AE17-4271-84B9-65768E32F59F}" type="datetimeFigureOut">
              <a:rPr lang="es-MX" smtClean="0"/>
              <a:pPr/>
              <a:t>22/05/2013</a:t>
            </a:fld>
            <a:endParaRPr lang="es-MX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MX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9FBCA3-9EBD-452C-BDD7-BCB7C68854B2}" type="slidenum">
              <a:rPr lang="es-MX" smtClean="0"/>
              <a:pPr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xmlns="" val="39839007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MX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s-MX" dirty="0" err="1" smtClean="0">
                <a:latin typeface="Times New Roman" pitchFamily="18" charset="0"/>
                <a:cs typeface="Times New Roman" pitchFamily="18" charset="0"/>
              </a:rPr>
              <a:t>Additional</a:t>
            </a:r>
            <a:r>
              <a:rPr lang="es-MX" dirty="0" smtClean="0">
                <a:latin typeface="Times New Roman" pitchFamily="18" charset="0"/>
                <a:cs typeface="Times New Roman" pitchFamily="18" charset="0"/>
              </a:rPr>
              <a:t> file</a:t>
            </a:r>
            <a:endParaRPr lang="es-MX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en-US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Estimation and evaluation of the propensity score</a:t>
            </a:r>
            <a:endParaRPr lang="es-MX" dirty="0">
              <a:solidFill>
                <a:schemeClr val="tx1"/>
              </a:solidFill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75412698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Rectángulo"/>
          <p:cNvSpPr/>
          <p:nvPr/>
        </p:nvSpPr>
        <p:spPr>
          <a:xfrm>
            <a:off x="35496" y="503094"/>
            <a:ext cx="7632848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Table 1a. Distribution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of variables before and after matching</a:t>
            </a:r>
            <a:endParaRPr lang="es-MX" sz="1200" dirty="0">
              <a:latin typeface="Times New Roman" pitchFamily="18" charset="0"/>
              <a:cs typeface="Times New Roman" pitchFamily="18" charset="0"/>
            </a:endParaRPr>
          </a:p>
        </p:txBody>
      </p:sp>
      <p:graphicFrame>
        <p:nvGraphicFramePr>
          <p:cNvPr id="4" name="3 Tabla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xmlns="" val="3359674321"/>
              </p:ext>
            </p:extLst>
          </p:nvPr>
        </p:nvGraphicFramePr>
        <p:xfrm>
          <a:off x="107503" y="836708"/>
          <a:ext cx="8928993" cy="5544620"/>
        </p:xfrm>
        <a:graphic>
          <a:graphicData uri="http://schemas.openxmlformats.org/drawingml/2006/table">
            <a:tbl>
              <a:tblPr/>
              <a:tblGrid>
                <a:gridCol w="2475801"/>
                <a:gridCol w="1124104"/>
                <a:gridCol w="907610"/>
                <a:gridCol w="716097"/>
                <a:gridCol w="1124104"/>
                <a:gridCol w="907610"/>
                <a:gridCol w="716097"/>
                <a:gridCol w="957570"/>
              </a:tblGrid>
              <a:tr h="213200">
                <a:tc>
                  <a:txBody>
                    <a:bodyPr/>
                    <a:lstStyle/>
                    <a:p>
                      <a:pPr algn="l" fontAlgn="b"/>
                      <a:r>
                        <a:rPr lang="es-MX" sz="10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Full </a:t>
                      </a:r>
                      <a:r>
                        <a:rPr lang="es-MX" sz="1000" b="0" i="0" u="none" strike="noStrike" dirty="0" err="1">
                          <a:solidFill>
                            <a:srgbClr val="000000"/>
                          </a:solidFill>
                          <a:latin typeface="Times New Roman"/>
                        </a:rPr>
                        <a:t>sample</a:t>
                      </a:r>
                      <a:endParaRPr lang="es-MX" sz="1000" b="0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s-MX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MX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Matched sample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s-MX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MX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fontAlgn="auto"/>
                      <a:r>
                        <a:rPr lang="es-MX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Percent Balance Improvement 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458380">
                <a:tc>
                  <a:txBody>
                    <a:bodyPr/>
                    <a:lstStyle/>
                    <a:p>
                      <a:pPr algn="l" fontAlgn="b"/>
                      <a:r>
                        <a:rPr lang="es-MX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auto"/>
                      <a:r>
                        <a:rPr lang="es-MX" sz="10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Non Oportunidades     n = 4406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auto"/>
                      <a:r>
                        <a:rPr lang="es-MX" sz="10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Oportunidades     n = 6890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Mean </a:t>
                      </a:r>
                      <a:r>
                        <a:rPr lang="es-MX" sz="1000" b="0" i="0" u="none" strike="noStrike" dirty="0" err="1">
                          <a:solidFill>
                            <a:srgbClr val="000000"/>
                          </a:solidFill>
                          <a:latin typeface="Times New Roman"/>
                        </a:rPr>
                        <a:t>diff</a:t>
                      </a:r>
                      <a:endParaRPr lang="es-MX" sz="1000" b="0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auto"/>
                      <a:r>
                        <a:rPr lang="es-MX" sz="10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Non Oportunidades     n = 2314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auto"/>
                      <a:r>
                        <a:rPr lang="es-MX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Oportunidades     n = 2314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Mean </a:t>
                      </a:r>
                      <a:r>
                        <a:rPr lang="es-MX" sz="1000" b="0" i="0" u="none" strike="noStrike" dirty="0" err="1">
                          <a:solidFill>
                            <a:srgbClr val="000000"/>
                          </a:solidFill>
                          <a:latin typeface="Times New Roman"/>
                        </a:rPr>
                        <a:t>diff</a:t>
                      </a:r>
                      <a:endParaRPr lang="es-MX" sz="1000" b="0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s-MX"/>
                    </a:p>
                  </a:txBody>
                  <a:tcPr/>
                </a:tc>
              </a:tr>
              <a:tr h="213200">
                <a:tc>
                  <a:txBody>
                    <a:bodyPr/>
                    <a:lstStyle/>
                    <a:p>
                      <a:pPr algn="l" fontAlgn="b"/>
                      <a:r>
                        <a:rPr lang="es-MX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Propensity score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5450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6551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0.1102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0.5000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5000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0000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100.00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13200">
                <a:tc>
                  <a:txBody>
                    <a:bodyPr/>
                    <a:lstStyle/>
                    <a:p>
                      <a:pPr algn="l" fontAlgn="b"/>
                      <a:r>
                        <a:rPr lang="es-MX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Sex (female)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4844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4817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0027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0.4700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0.4700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0000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100.00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13200">
                <a:tc>
                  <a:txBody>
                    <a:bodyPr/>
                    <a:lstStyle/>
                    <a:p>
                      <a:pPr algn="l" fontAlgn="b"/>
                      <a:r>
                        <a:rPr lang="es-MX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Indigenous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2149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3285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0.1136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2208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0.2208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0.0000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100.00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1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Older people with health insurance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3603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5718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0.2115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4347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4347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0.0000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100.00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13200">
                <a:tc>
                  <a:txBody>
                    <a:bodyPr/>
                    <a:lstStyle/>
                    <a:p>
                      <a:pPr algn="l" fontAlgn="b"/>
                      <a:r>
                        <a:rPr lang="es-MX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Household with TV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6403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6765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0.0363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6340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6340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0.0000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100.00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13200">
                <a:tc>
                  <a:txBody>
                    <a:bodyPr/>
                    <a:lstStyle/>
                    <a:p>
                      <a:pPr algn="l" fontAlgn="b"/>
                      <a:r>
                        <a:rPr lang="es-MX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Household with refrigerator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4711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4145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0565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4270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4270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0.0000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100.00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13200">
                <a:tc>
                  <a:txBody>
                    <a:bodyPr/>
                    <a:lstStyle/>
                    <a:p>
                      <a:pPr algn="l" fontAlgn="b"/>
                      <a:r>
                        <a:rPr lang="es-MX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Household with gas stove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5112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4139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0973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4598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4598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0.0000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100.00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13200">
                <a:tc>
                  <a:txBody>
                    <a:bodyPr/>
                    <a:lstStyle/>
                    <a:p>
                      <a:pPr algn="l" fontAlgn="b"/>
                      <a:r>
                        <a:rPr lang="es-MX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Household with auto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1262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0648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0613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0575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0575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0000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100.00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13200">
                <a:tc>
                  <a:txBody>
                    <a:bodyPr/>
                    <a:lstStyle/>
                    <a:p>
                      <a:pPr algn="l" fontAlgn="b"/>
                      <a:r>
                        <a:rPr lang="es-MX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Household with children &lt;= 13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3410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5191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0.1782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3600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3600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0000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100.00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1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Household crowd index (1rst quartile)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4546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2923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1623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4101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4101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0000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100.00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1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Household crowd index (2nd quartile)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3147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3677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0.0530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3328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3328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0000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100.00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1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Household crowd index (3erd quartile)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2307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3400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0.1093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2571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2571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0000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100.00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13200">
                <a:tc>
                  <a:txBody>
                    <a:bodyPr/>
                    <a:lstStyle/>
                    <a:p>
                      <a:pPr algn="l" fontAlgn="b"/>
                      <a:r>
                        <a:rPr lang="es-MX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Household head schooling (illiterate)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4314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4563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0.0248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4719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4719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0000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100.00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41112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Household head schooling (incomplete primary)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4771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4276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0495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4806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4806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0000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100.00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1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Household head schooling (complete primary)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0620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0883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0.0262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0406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0406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0000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100.00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41112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Household head schooling (complete secondary)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0295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0279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0016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0069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0069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0000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100.00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13200">
                <a:tc>
                  <a:txBody>
                    <a:bodyPr/>
                    <a:lstStyle/>
                    <a:p>
                      <a:pPr algn="l" fontAlgn="b"/>
                      <a:r>
                        <a:rPr lang="es-MX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Household with dirt floor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2977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3918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0.0941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3073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3073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0000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100.00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13200">
                <a:tc>
                  <a:txBody>
                    <a:bodyPr/>
                    <a:lstStyle/>
                    <a:p>
                      <a:pPr algn="l" fontAlgn="b"/>
                      <a:r>
                        <a:rPr lang="es-MX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Household with stereo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3128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3626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0.0498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2904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2904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0000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100.00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13200">
                <a:tc>
                  <a:txBody>
                    <a:bodyPr/>
                    <a:lstStyle/>
                    <a:p>
                      <a:pPr algn="l" fontAlgn="b"/>
                      <a:r>
                        <a:rPr lang="es-MX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Locality deprivation index (1rst quartile)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3947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2946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1001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3613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3613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0000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100.00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1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Locality deprivation index (2nd quartile)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3292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3392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0.0099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3349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3349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0000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100.00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13200">
                <a:tc>
                  <a:txBody>
                    <a:bodyPr/>
                    <a:lstStyle/>
                    <a:p>
                      <a:pPr algn="l" fontAlgn="b"/>
                      <a:r>
                        <a:rPr lang="es-MX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Locality deprivation index (3erd quartile)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2761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3662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0.0901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3038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3038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0000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MX" sz="10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100.00</a:t>
                      </a:r>
                    </a:p>
                  </a:txBody>
                  <a:tcPr marL="5680" marR="5680" marT="56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xmlns="" val="96519620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Rectángulo"/>
          <p:cNvSpPr/>
          <p:nvPr/>
        </p:nvSpPr>
        <p:spPr>
          <a:xfrm>
            <a:off x="179512" y="519063"/>
            <a:ext cx="8496944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Figure 1a. 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Propensity score distribution before and after matching</a:t>
            </a:r>
            <a:endParaRPr lang="es-MX" sz="12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3" name="2 Imagen"/>
          <p:cNvPicPr/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213048" y="966043"/>
            <a:ext cx="8535416" cy="411914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4" name="3 Rectángulo"/>
          <p:cNvSpPr/>
          <p:nvPr/>
        </p:nvSpPr>
        <p:spPr>
          <a:xfrm>
            <a:off x="467544" y="5157192"/>
            <a:ext cx="813690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                      Before </a:t>
            </a:r>
            <a:r>
              <a:rPr lang="en-US" dirty="0">
                <a:latin typeface="Times New Roman" pitchFamily="18" charset="0"/>
                <a:cs typeface="Times New Roman" pitchFamily="18" charset="0"/>
              </a:rPr>
              <a:t>matching		</a:t>
            </a:r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	After </a:t>
            </a:r>
            <a:r>
              <a:rPr lang="en-US" dirty="0">
                <a:latin typeface="Times New Roman" pitchFamily="18" charset="0"/>
                <a:cs typeface="Times New Roman" pitchFamily="18" charset="0"/>
              </a:rPr>
              <a:t>matching</a:t>
            </a:r>
            <a:endParaRPr lang="es-MX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96601492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5</TotalTime>
  <Words>327</Words>
  <Application>Microsoft Office PowerPoint</Application>
  <PresentationFormat>Presentación en pantalla (4:3)</PresentationFormat>
  <Paragraphs>184</Paragraphs>
  <Slides>3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3</vt:i4>
      </vt:variant>
    </vt:vector>
  </HeadingPairs>
  <TitlesOfParts>
    <vt:vector size="4" baseType="lpstr">
      <vt:lpstr>Tema de Office</vt:lpstr>
      <vt:lpstr>Additional file</vt:lpstr>
      <vt:lpstr>Diapositiva 2</vt:lpstr>
      <vt:lpstr>Diapositiva 3</vt:lpstr>
    </vt:vector>
  </TitlesOfParts>
  <Company>Microsoft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dditional file</dc:title>
  <dc:creator>asalinas</dc:creator>
  <cp:lastModifiedBy>asalinas</cp:lastModifiedBy>
  <cp:revision>22</cp:revision>
  <dcterms:created xsi:type="dcterms:W3CDTF">2013-02-08T00:18:38Z</dcterms:created>
  <dcterms:modified xsi:type="dcterms:W3CDTF">2013-05-22T19:50:19Z</dcterms:modified>
</cp:coreProperties>
</file>